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4" d="100"/>
          <a:sy n="44" d="100"/>
        </p:scale>
        <p:origin x="225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牧野 友幸" userId="3418e839-faa9-476d-b509-1fc4b11e6ea9" providerId="ADAL" clId="{90BD3816-FC9B-40C8-8990-178ED72D4F04}"/>
    <pc:docChg chg="undo custSel modSld">
      <pc:chgData name="牧野 友幸" userId="3418e839-faa9-476d-b509-1fc4b11e6ea9" providerId="ADAL" clId="{90BD3816-FC9B-40C8-8990-178ED72D4F04}" dt="2026-01-08T13:58:55.070" v="359" actId="1035"/>
      <pc:docMkLst>
        <pc:docMk/>
      </pc:docMkLst>
      <pc:sldChg chg="addSp modSp mod">
        <pc:chgData name="牧野 友幸" userId="3418e839-faa9-476d-b509-1fc4b11e6ea9" providerId="ADAL" clId="{90BD3816-FC9B-40C8-8990-178ED72D4F04}" dt="2026-01-08T13:58:55.070" v="359" actId="1035"/>
        <pc:sldMkLst>
          <pc:docMk/>
          <pc:sldMk cId="2226767344" sldId="273"/>
        </pc:sldMkLst>
        <pc:spChg chg="add mod">
          <ac:chgData name="牧野 友幸" userId="3418e839-faa9-476d-b509-1fc4b11e6ea9" providerId="ADAL" clId="{90BD3816-FC9B-40C8-8990-178ED72D4F04}" dt="2026-01-08T13:58:55.070" v="359" actId="1035"/>
          <ac:spMkLst>
            <pc:docMk/>
            <pc:sldMk cId="2226767344" sldId="273"/>
            <ac:spMk id="2" creationId="{F73C8A36-DA27-760A-2C46-8FEA4CE5E72E}"/>
          </ac:spMkLst>
        </pc:spChg>
        <pc:spChg chg="mod">
          <ac:chgData name="牧野 友幸" userId="3418e839-faa9-476d-b509-1fc4b11e6ea9" providerId="ADAL" clId="{90BD3816-FC9B-40C8-8990-178ED72D4F04}" dt="2026-01-08T13:57:05.438" v="344" actId="1038"/>
          <ac:spMkLst>
            <pc:docMk/>
            <pc:sldMk cId="2226767344" sldId="273"/>
            <ac:spMk id="4" creationId="{9B6AC1B4-33BB-2E36-7247-8485AF499DE6}"/>
          </ac:spMkLst>
        </pc:spChg>
        <pc:spChg chg="add mod">
          <ac:chgData name="牧野 友幸" userId="3418e839-faa9-476d-b509-1fc4b11e6ea9" providerId="ADAL" clId="{90BD3816-FC9B-40C8-8990-178ED72D4F04}" dt="2026-01-08T13:58:55.070" v="359" actId="1035"/>
          <ac:spMkLst>
            <pc:docMk/>
            <pc:sldMk cId="2226767344" sldId="273"/>
            <ac:spMk id="12" creationId="{4957EBC5-662B-D74E-E9A8-36CC934A33F4}"/>
          </ac:spMkLst>
        </pc:spChg>
        <pc:spChg chg="mod">
          <ac:chgData name="牧野 友幸" userId="3418e839-faa9-476d-b509-1fc4b11e6ea9" providerId="ADAL" clId="{90BD3816-FC9B-40C8-8990-178ED72D4F04}" dt="2026-01-08T13:57:05.438" v="344" actId="1038"/>
          <ac:spMkLst>
            <pc:docMk/>
            <pc:sldMk cId="2226767344" sldId="273"/>
            <ac:spMk id="31" creationId="{5B4961C8-DD46-00A8-D560-3D63583D3A46}"/>
          </ac:spMkLst>
        </pc:spChg>
        <pc:spChg chg="mod">
          <ac:chgData name="牧野 友幸" userId="3418e839-faa9-476d-b509-1fc4b11e6ea9" providerId="ADAL" clId="{90BD3816-FC9B-40C8-8990-178ED72D4F04}" dt="2026-01-08T13:57:05.438" v="344" actId="1038"/>
          <ac:spMkLst>
            <pc:docMk/>
            <pc:sldMk cId="2226767344" sldId="273"/>
            <ac:spMk id="36" creationId="{59D9577A-F1B7-BFDD-4312-ADA8098B6EA3}"/>
          </ac:spMkLst>
        </pc:spChg>
        <pc:spChg chg="mod">
          <ac:chgData name="牧野 友幸" userId="3418e839-faa9-476d-b509-1fc4b11e6ea9" providerId="ADAL" clId="{90BD3816-FC9B-40C8-8990-178ED72D4F04}" dt="2026-01-08T13:57:05.438" v="344" actId="1038"/>
          <ac:spMkLst>
            <pc:docMk/>
            <pc:sldMk cId="2226767344" sldId="273"/>
            <ac:spMk id="41" creationId="{A7828BE6-DE23-09EB-FCD9-80000E20D966}"/>
          </ac:spMkLst>
        </pc:spChg>
        <pc:graphicFrameChg chg="mod">
          <ac:chgData name="牧野 友幸" userId="3418e839-faa9-476d-b509-1fc4b11e6ea9" providerId="ADAL" clId="{90BD3816-FC9B-40C8-8990-178ED72D4F04}" dt="2026-01-08T13:57:05.438" v="344" actId="1038"/>
          <ac:graphicFrameMkLst>
            <pc:docMk/>
            <pc:sldMk cId="2226767344" sldId="273"/>
            <ac:graphicFrameMk id="5" creationId="{25B49C77-6791-79D1-1C5A-2BA4AC30EC07}"/>
          </ac:graphicFrameMkLst>
        </pc:graphicFrameChg>
        <pc:graphicFrameChg chg="mod modGraphic">
          <ac:chgData name="牧野 友幸" userId="3418e839-faa9-476d-b509-1fc4b11e6ea9" providerId="ADAL" clId="{90BD3816-FC9B-40C8-8990-178ED72D4F04}" dt="2026-01-08T13:57:05.438" v="344" actId="1038"/>
          <ac:graphicFrameMkLst>
            <pc:docMk/>
            <pc:sldMk cId="2226767344" sldId="273"/>
            <ac:graphicFrameMk id="6" creationId="{2E22CFCB-8CF6-4E2E-1DCF-B0EAC59608D4}"/>
          </ac:graphicFrameMkLst>
        </pc:graphicFrameChg>
        <pc:graphicFrameChg chg="add mod">
          <ac:chgData name="牧野 友幸" userId="3418e839-faa9-476d-b509-1fc4b11e6ea9" providerId="ADAL" clId="{90BD3816-FC9B-40C8-8990-178ED72D4F04}" dt="2026-01-08T13:58:55.070" v="359" actId="1035"/>
          <ac:graphicFrameMkLst>
            <pc:docMk/>
            <pc:sldMk cId="2226767344" sldId="273"/>
            <ac:graphicFrameMk id="8" creationId="{1CDF1EA4-C38E-51A4-F0FE-1C5D956FB54D}"/>
          </ac:graphicFrameMkLst>
        </pc:graphicFrameChg>
        <pc:graphicFrameChg chg="add mod modGraphic">
          <ac:chgData name="牧野 友幸" userId="3418e839-faa9-476d-b509-1fc4b11e6ea9" providerId="ADAL" clId="{90BD3816-FC9B-40C8-8990-178ED72D4F04}" dt="2026-01-08T13:58:55.070" v="359" actId="1035"/>
          <ac:graphicFrameMkLst>
            <pc:docMk/>
            <pc:sldMk cId="2226767344" sldId="273"/>
            <ac:graphicFrameMk id="11" creationId="{4B6BA7E0-B901-5EE7-0BCA-20E84976EA22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527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380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513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315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571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647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159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40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31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437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2293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76D0FA-ED3A-4DC5-91CD-84FBE795C6FD}" type="datetimeFigureOut">
              <a:rPr kumimoji="1" lang="ja-JP" altLang="en-US" smtClean="0"/>
              <a:t>2026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683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75CDC85-E368-E6DB-CACA-69C3775F4F05}"/>
              </a:ext>
            </a:extLst>
          </p:cNvPr>
          <p:cNvSpPr txBox="1"/>
          <p:nvPr/>
        </p:nvSpPr>
        <p:spPr>
          <a:xfrm>
            <a:off x="434867" y="335209"/>
            <a:ext cx="598826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Figure S1. Recurrence-free survival after HDR-BT stratified by (a) age, (b) initial PSA, (c) Grade Group (GG), (d) NCCN risk group, and (e) RT protocol.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B6AC1B4-33BB-2E36-7247-8485AF499DE6}"/>
              </a:ext>
            </a:extLst>
          </p:cNvPr>
          <p:cNvSpPr txBox="1"/>
          <p:nvPr/>
        </p:nvSpPr>
        <p:spPr>
          <a:xfrm>
            <a:off x="587049" y="1157738"/>
            <a:ext cx="43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C2D3C39-2807-5083-713B-CC180B602F16}"/>
              </a:ext>
            </a:extLst>
          </p:cNvPr>
          <p:cNvSpPr txBox="1"/>
          <p:nvPr/>
        </p:nvSpPr>
        <p:spPr>
          <a:xfrm>
            <a:off x="3566420" y="1157738"/>
            <a:ext cx="43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9D9577A-F1B7-BFDD-4312-ADA8098B6EA3}"/>
              </a:ext>
            </a:extLst>
          </p:cNvPr>
          <p:cNvSpPr txBox="1"/>
          <p:nvPr/>
        </p:nvSpPr>
        <p:spPr>
          <a:xfrm>
            <a:off x="587049" y="3568264"/>
            <a:ext cx="43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963377BE-4995-B11C-A205-A13881EDF6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5420274"/>
              </p:ext>
            </p:extLst>
          </p:nvPr>
        </p:nvGraphicFramePr>
        <p:xfrm>
          <a:off x="3981450" y="1387475"/>
          <a:ext cx="2232025" cy="1584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3901350" imgH="2771745" progId="Prism6.Document">
                  <p:embed/>
                </p:oleObj>
              </mc:Choice>
              <mc:Fallback>
                <p:oleObj name="Prism 6" r:id="rId2" imgW="3901350" imgH="2771745" progId="Prism6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963377BE-4995-B11C-A205-A13881EDF6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81450" y="1387475"/>
                        <a:ext cx="2232025" cy="1584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489ABE74-8CAE-94F0-FF61-B776D7FA66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883467"/>
              </p:ext>
            </p:extLst>
          </p:nvPr>
        </p:nvGraphicFramePr>
        <p:xfrm>
          <a:off x="956105" y="3795713"/>
          <a:ext cx="2232000" cy="158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3901350" imgH="2771745" progId="Prism6.Document">
                  <p:embed/>
                </p:oleObj>
              </mc:Choice>
              <mc:Fallback>
                <p:oleObj name="Prism 6" r:id="rId4" imgW="3901350" imgH="2771745" progId="Prism6.Document">
                  <p:embed/>
                  <p:pic>
                    <p:nvPicPr>
                      <p:cNvPr id="10" name="オブジェクト 9">
                        <a:extLst>
                          <a:ext uri="{FF2B5EF4-FFF2-40B4-BE49-F238E27FC236}">
                            <a16:creationId xmlns:a16="http://schemas.microsoft.com/office/drawing/2014/main" id="{489ABE74-8CAE-94F0-FF61-B776D7FA66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56105" y="3795713"/>
                        <a:ext cx="2232000" cy="158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オブジェクト 19">
            <a:extLst>
              <a:ext uri="{FF2B5EF4-FFF2-40B4-BE49-F238E27FC236}">
                <a16:creationId xmlns:a16="http://schemas.microsoft.com/office/drawing/2014/main" id="{A55CD0C5-DFDE-7929-43BD-058019745F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8734970"/>
              </p:ext>
            </p:extLst>
          </p:nvPr>
        </p:nvGraphicFramePr>
        <p:xfrm>
          <a:off x="3981450" y="3795713"/>
          <a:ext cx="2232025" cy="1584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3901350" imgH="2771745" progId="Prism6.Document">
                  <p:embed/>
                </p:oleObj>
              </mc:Choice>
              <mc:Fallback>
                <p:oleObj name="Prism 6" r:id="rId6" imgW="3901350" imgH="2771745" progId="Prism6.Document">
                  <p:embed/>
                  <p:pic>
                    <p:nvPicPr>
                      <p:cNvPr id="20" name="オブジェクト 19">
                        <a:extLst>
                          <a:ext uri="{FF2B5EF4-FFF2-40B4-BE49-F238E27FC236}">
                            <a16:creationId xmlns:a16="http://schemas.microsoft.com/office/drawing/2014/main" id="{A55CD0C5-DFDE-7929-43BD-058019745F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81450" y="3795713"/>
                        <a:ext cx="2232025" cy="1584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B4961C8-DD46-00A8-D560-3D63583D3A46}"/>
              </a:ext>
            </a:extLst>
          </p:cNvPr>
          <p:cNvSpPr txBox="1"/>
          <p:nvPr/>
        </p:nvSpPr>
        <p:spPr>
          <a:xfrm>
            <a:off x="775163" y="2841362"/>
            <a:ext cx="612000" cy="200055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</a:p>
        </p:txBody>
      </p:sp>
      <p:graphicFrame>
        <p:nvGraphicFramePr>
          <p:cNvPr id="32" name="表 31">
            <a:extLst>
              <a:ext uri="{FF2B5EF4-FFF2-40B4-BE49-F238E27FC236}">
                <a16:creationId xmlns:a16="http://schemas.microsoft.com/office/drawing/2014/main" id="{50653092-AF0E-63BA-AA01-6003E045F4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8828123"/>
              </p:ext>
            </p:extLst>
          </p:nvPr>
        </p:nvGraphicFramePr>
        <p:xfrm>
          <a:off x="3770439" y="3035921"/>
          <a:ext cx="2268000" cy="432000"/>
        </p:xfrm>
        <a:graphic>
          <a:graphicData uri="http://schemas.openxmlformats.org/drawingml/2006/table">
            <a:tbl>
              <a:tblPr/>
              <a:tblGrid>
                <a:gridCol w="504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9662883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301335211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26488211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23646965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25279916"/>
                    </a:ext>
                  </a:extLst>
                </a:gridCol>
              </a:tblGrid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SA</a:t>
                      </a:r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≤</a:t>
                      </a: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0&lt;PSA</a:t>
                      </a:r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≤</a:t>
                      </a: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238333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&lt;PS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24620657"/>
                  </a:ext>
                </a:extLst>
              </a:tr>
            </a:tbl>
          </a:graphicData>
        </a:graphic>
      </p:graphicFrame>
      <p:graphicFrame>
        <p:nvGraphicFramePr>
          <p:cNvPr id="40" name="表 39">
            <a:extLst>
              <a:ext uri="{FF2B5EF4-FFF2-40B4-BE49-F238E27FC236}">
                <a16:creationId xmlns:a16="http://schemas.microsoft.com/office/drawing/2014/main" id="{EEA9FC19-759C-21B8-2DB2-D900990E63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62312"/>
              </p:ext>
            </p:extLst>
          </p:nvPr>
        </p:nvGraphicFramePr>
        <p:xfrm>
          <a:off x="768813" y="5443811"/>
          <a:ext cx="2232000" cy="288000"/>
        </p:xfrm>
        <a:graphic>
          <a:graphicData uri="http://schemas.openxmlformats.org/drawingml/2006/table">
            <a:tbl>
              <a:tblPr/>
              <a:tblGrid>
                <a:gridCol w="468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9662883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301335211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26488211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23646965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25279916"/>
                    </a:ext>
                  </a:extLst>
                </a:gridCol>
              </a:tblGrid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G 1-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G 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2383339"/>
                  </a:ext>
                </a:extLst>
              </a:tr>
            </a:tbl>
          </a:graphicData>
        </a:graphic>
      </p:graphicFrame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A7828BE6-DE23-09EB-FCD9-80000E20D966}"/>
              </a:ext>
            </a:extLst>
          </p:cNvPr>
          <p:cNvSpPr txBox="1"/>
          <p:nvPr/>
        </p:nvSpPr>
        <p:spPr>
          <a:xfrm>
            <a:off x="768813" y="5249252"/>
            <a:ext cx="612000" cy="200055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44EF523-C649-69DC-D465-21F2A5A02E82}"/>
              </a:ext>
            </a:extLst>
          </p:cNvPr>
          <p:cNvSpPr txBox="1"/>
          <p:nvPr/>
        </p:nvSpPr>
        <p:spPr>
          <a:xfrm>
            <a:off x="3770439" y="2841362"/>
            <a:ext cx="612000" cy="200055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</a:p>
        </p:txBody>
      </p:sp>
      <p:graphicFrame>
        <p:nvGraphicFramePr>
          <p:cNvPr id="44" name="表 43">
            <a:extLst>
              <a:ext uri="{FF2B5EF4-FFF2-40B4-BE49-F238E27FC236}">
                <a16:creationId xmlns:a16="http://schemas.microsoft.com/office/drawing/2014/main" id="{1EAF8CB8-EAFD-349B-9425-BBE0CFEBA9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7876980"/>
              </p:ext>
            </p:extLst>
          </p:nvPr>
        </p:nvGraphicFramePr>
        <p:xfrm>
          <a:off x="3802189" y="5443811"/>
          <a:ext cx="2232000" cy="432000"/>
        </p:xfrm>
        <a:graphic>
          <a:graphicData uri="http://schemas.openxmlformats.org/drawingml/2006/table">
            <a:tbl>
              <a:tblPr/>
              <a:tblGrid>
                <a:gridCol w="468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9662883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301335211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26488211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23646965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25279916"/>
                    </a:ext>
                  </a:extLst>
                </a:gridCol>
              </a:tblGrid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VHR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VHR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238333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egiona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24620657"/>
                  </a:ext>
                </a:extLst>
              </a:tr>
            </a:tbl>
          </a:graphicData>
        </a:graphic>
      </p:graphicFrame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22B9CC94-0DD5-3215-6D0D-6C0CB93C29FD}"/>
              </a:ext>
            </a:extLst>
          </p:cNvPr>
          <p:cNvSpPr txBox="1"/>
          <p:nvPr/>
        </p:nvSpPr>
        <p:spPr>
          <a:xfrm>
            <a:off x="3802189" y="5249252"/>
            <a:ext cx="612000" cy="200055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</a:p>
        </p:txBody>
      </p:sp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25B49C77-6791-79D1-1C5A-2BA4AC30EC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8647763"/>
              </p:ext>
            </p:extLst>
          </p:nvPr>
        </p:nvGraphicFramePr>
        <p:xfrm>
          <a:off x="954765" y="1387475"/>
          <a:ext cx="2233340" cy="158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8" imgW="3901350" imgH="2771745" progId="Prism6.Document">
                  <p:embed/>
                </p:oleObj>
              </mc:Choice>
              <mc:Fallback>
                <p:oleObj name="Prism 6" r:id="rId8" imgW="3901350" imgH="2771745" progId="Prism6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25B49C77-6791-79D1-1C5A-2BA4AC30EC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54765" y="1387475"/>
                        <a:ext cx="2233340" cy="158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2E22CFCB-8CF6-4E2E-1DCF-B0EAC59608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5414261"/>
              </p:ext>
            </p:extLst>
          </p:nvPr>
        </p:nvGraphicFramePr>
        <p:xfrm>
          <a:off x="775163" y="3035921"/>
          <a:ext cx="2232000" cy="288000"/>
        </p:xfrm>
        <a:graphic>
          <a:graphicData uri="http://schemas.openxmlformats.org/drawingml/2006/table">
            <a:tbl>
              <a:tblPr/>
              <a:tblGrid>
                <a:gridCol w="468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9662883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301335211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26488211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23646965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25279916"/>
                    </a:ext>
                  </a:extLst>
                </a:gridCol>
              </a:tblGrid>
              <a:tr h="1440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ge </a:t>
                      </a:r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≤</a:t>
                      </a: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ge &gt;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2383339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9484812-058F-C93C-C63B-AB856A8CAE5F}"/>
              </a:ext>
            </a:extLst>
          </p:cNvPr>
          <p:cNvSpPr txBox="1"/>
          <p:nvPr/>
        </p:nvSpPr>
        <p:spPr>
          <a:xfrm>
            <a:off x="3566420" y="3568264"/>
            <a:ext cx="43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73C8A36-DA27-760A-2C46-8FEA4CE5E72E}"/>
              </a:ext>
            </a:extLst>
          </p:cNvPr>
          <p:cNvSpPr txBox="1"/>
          <p:nvPr/>
        </p:nvSpPr>
        <p:spPr>
          <a:xfrm>
            <a:off x="587049" y="6025174"/>
            <a:ext cx="43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1CDF1EA4-C38E-51A4-F0FE-1C5D956FB5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3339031"/>
              </p:ext>
            </p:extLst>
          </p:nvPr>
        </p:nvGraphicFramePr>
        <p:xfrm>
          <a:off x="956105" y="6307678"/>
          <a:ext cx="2232000" cy="158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0" imgW="3901350" imgH="2771745" progId="Prism6.Document">
                  <p:embed/>
                </p:oleObj>
              </mc:Choice>
              <mc:Fallback>
                <p:oleObj name="Prism 6" r:id="rId10" imgW="3901350" imgH="2771745" progId="Prism6.Document">
                  <p:embed/>
                  <p:pic>
                    <p:nvPicPr>
                      <p:cNvPr id="8" name="オブジェクト 7">
                        <a:extLst>
                          <a:ext uri="{FF2B5EF4-FFF2-40B4-BE49-F238E27FC236}">
                            <a16:creationId xmlns:a16="http://schemas.microsoft.com/office/drawing/2014/main" id="{1CDF1EA4-C38E-51A4-F0FE-1C5D956FB5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956105" y="6307678"/>
                        <a:ext cx="2232000" cy="158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4B6BA7E0-B901-5EE7-0BCA-20E84976EA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1376410"/>
              </p:ext>
            </p:extLst>
          </p:nvPr>
        </p:nvGraphicFramePr>
        <p:xfrm>
          <a:off x="775163" y="7977547"/>
          <a:ext cx="2232000" cy="432000"/>
        </p:xfrm>
        <a:graphic>
          <a:graphicData uri="http://schemas.openxmlformats.org/drawingml/2006/table">
            <a:tbl>
              <a:tblPr/>
              <a:tblGrid>
                <a:gridCol w="468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9662883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3013352116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26488211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123646965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1425279916"/>
                    </a:ext>
                  </a:extLst>
                </a:gridCol>
              </a:tblGrid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rotocol 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rotocol 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238333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rotocol 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24620657"/>
                  </a:ext>
                </a:extLst>
              </a:tr>
            </a:tbl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957EBC5-662B-D74E-E9A8-36CC934A33F4}"/>
              </a:ext>
            </a:extLst>
          </p:cNvPr>
          <p:cNvSpPr txBox="1"/>
          <p:nvPr/>
        </p:nvSpPr>
        <p:spPr>
          <a:xfrm>
            <a:off x="775163" y="7782988"/>
            <a:ext cx="612000" cy="200055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</a:p>
        </p:txBody>
      </p:sp>
    </p:spTree>
    <p:extLst>
      <p:ext uri="{BB962C8B-B14F-4D97-AF65-F5344CB8AC3E}">
        <p14:creationId xmlns:p14="http://schemas.microsoft.com/office/powerpoint/2010/main" val="2226767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13</TotalTime>
  <Words>227</Words>
  <Application>Microsoft Office PowerPoint</Application>
  <PresentationFormat>A4 210 x 297 mm</PresentationFormat>
  <Paragraphs>154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Office テーマ</vt:lpstr>
      <vt:lpstr>Prism 6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牧野 友幸</dc:creator>
  <cp:lastModifiedBy>牧野 友幸</cp:lastModifiedBy>
  <cp:revision>7</cp:revision>
  <dcterms:created xsi:type="dcterms:W3CDTF">2024-04-25T10:20:30Z</dcterms:created>
  <dcterms:modified xsi:type="dcterms:W3CDTF">2026-01-08T13:59:00Z</dcterms:modified>
</cp:coreProperties>
</file>